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95" userDrawn="1">
          <p15:clr>
            <a:srgbClr val="A4A3A4"/>
          </p15:clr>
        </p15:guide>
        <p15:guide id="2" pos="1323" userDrawn="1">
          <p15:clr>
            <a:srgbClr val="A4A3A4"/>
          </p15:clr>
        </p15:guide>
        <p15:guide id="3" orient="horz" pos="777" userDrawn="1">
          <p15:clr>
            <a:srgbClr val="A4A3A4"/>
          </p15:clr>
        </p15:guide>
        <p15:guide id="4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HeeJoong Lee" initials="Lee" lastIdx="4" clrIdx="0">
    <p:extLst>
      <p:ext uri="{19B8F6BF-5375-455C-9EA6-DF929625EA0E}">
        <p15:presenceInfo xmlns:p15="http://schemas.microsoft.com/office/powerpoint/2012/main" userId="HeeJoong Lee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1141" autoAdjust="0"/>
  </p:normalViewPr>
  <p:slideViewPr>
    <p:cSldViewPr snapToGrid="0">
      <p:cViewPr varScale="1">
        <p:scale>
          <a:sx n="77" d="100"/>
          <a:sy n="77" d="100"/>
        </p:scale>
        <p:origin x="806" y="72"/>
      </p:cViewPr>
      <p:guideLst>
        <p:guide orient="horz" pos="595"/>
        <p:guide pos="1323"/>
        <p:guide orient="horz" pos="777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5B55E22-3B9A-4D2C-A739-37567EA8C95B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929D4F8-23FB-4C07-A8F0-B30230CBB7E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32888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latinLnBrk="1"/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929D4F8-23FB-4C07-A8F0-B30230CBB7E6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069577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375517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582966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219935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08757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459726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82864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099583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78805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656395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2863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36536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118182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0" y="313986"/>
            <a:ext cx="1219199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ko-K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6. </a:t>
            </a:r>
            <a:r>
              <a:rPr lang="en-US" altLang="ko-KR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RT </a:t>
            </a:r>
            <a:r>
              <a:rPr lang="en-US" altLang="ko-K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uration distributions in women with endometriosis diagnosed with ovarian cancer. </a:t>
            </a:r>
            <a:endParaRPr lang="ko-KR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58913" y="1545942"/>
            <a:ext cx="7874173" cy="51252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911789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0</TotalTime>
  <Words>16</Words>
  <Application>Microsoft Office PowerPoint</Application>
  <PresentationFormat>와이드스크린</PresentationFormat>
  <Paragraphs>3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Eunjeong Ji</dc:creator>
  <cp:lastModifiedBy>Banghyun Lee</cp:lastModifiedBy>
  <cp:revision>38</cp:revision>
  <dcterms:created xsi:type="dcterms:W3CDTF">2022-01-28T09:16:13Z</dcterms:created>
  <dcterms:modified xsi:type="dcterms:W3CDTF">2023-02-06T09:26:03Z</dcterms:modified>
</cp:coreProperties>
</file>